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9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49" d="100"/>
          <a:sy n="49" d="100"/>
        </p:scale>
        <p:origin x="289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217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518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255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73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743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4404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8672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452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44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992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224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852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10924D5D-A3E7-4BAC-AC1E-6209001E8DA8}"/>
              </a:ext>
            </a:extLst>
          </p:cNvPr>
          <p:cNvSpPr txBox="1"/>
          <p:nvPr/>
        </p:nvSpPr>
        <p:spPr>
          <a:xfrm>
            <a:off x="640834" y="8462894"/>
            <a:ext cx="10910332" cy="995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956" b="1" dirty="0">
                <a:latin typeface="Arial" panose="020B0604020202020204" pitchFamily="34" charset="0"/>
                <a:cs typeface="Arial" panose="020B0604020202020204" pitchFamily="34" charset="0"/>
              </a:rPr>
              <a:t>Fig. S1. gp100 and ovalbumin (OVA) expression in indicated mouse melanoma cell lines. </a:t>
            </a:r>
            <a:r>
              <a:rPr lang="en-US" sz="1956" dirty="0">
                <a:latin typeface="Arial" panose="020B0604020202020204" pitchFamily="34" charset="0"/>
                <a:cs typeface="Arial" panose="020B0604020202020204" pitchFamily="34" charset="0"/>
              </a:rPr>
              <a:t>Cell lysates were analyzed with immunoblotting. GAPDH levels are shown as a protein loading control.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8D8239E-75CD-4841-AB24-1452A7555342}"/>
              </a:ext>
            </a:extLst>
          </p:cNvPr>
          <p:cNvSpPr txBox="1"/>
          <p:nvPr/>
        </p:nvSpPr>
        <p:spPr>
          <a:xfrm>
            <a:off x="3919693" y="6165974"/>
            <a:ext cx="794064" cy="3659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78" b="1" dirty="0">
                <a:latin typeface="Arial" panose="020B0604020202020204" pitchFamily="34" charset="0"/>
                <a:cs typeface="Arial" panose="020B0604020202020204" pitchFamily="34" charset="0"/>
              </a:rPr>
              <a:t>OVA -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86D8FDD-3D2B-44B0-A145-B611BB3153CD}"/>
              </a:ext>
            </a:extLst>
          </p:cNvPr>
          <p:cNvSpPr txBox="1"/>
          <p:nvPr/>
        </p:nvSpPr>
        <p:spPr>
          <a:xfrm>
            <a:off x="3605744" y="6757750"/>
            <a:ext cx="1149674" cy="3659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78" b="1" dirty="0">
                <a:latin typeface="Arial" panose="020B0604020202020204" pitchFamily="34" charset="0"/>
                <a:cs typeface="Arial" panose="020B0604020202020204" pitchFamily="34" charset="0"/>
              </a:rPr>
              <a:t>GAPDH -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05B755E5-283A-4A69-9CF7-76A42EEC7D90}"/>
              </a:ext>
            </a:extLst>
          </p:cNvPr>
          <p:cNvSpPr/>
          <p:nvPr/>
        </p:nvSpPr>
        <p:spPr>
          <a:xfrm rot="18451730">
            <a:off x="4737055" y="4508944"/>
            <a:ext cx="1845377" cy="36593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778" b="1" dirty="0">
                <a:latin typeface="Arial" panose="020B0604020202020204" pitchFamily="34" charset="0"/>
                <a:cs typeface="Arial" panose="020B0604020202020204" pitchFamily="34" charset="0"/>
              </a:rPr>
              <a:t>B16-Red Fluc-3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E2D006F7-248E-46AB-B98F-8CCBFAD3C773}"/>
              </a:ext>
            </a:extLst>
          </p:cNvPr>
          <p:cNvSpPr/>
          <p:nvPr/>
        </p:nvSpPr>
        <p:spPr>
          <a:xfrm rot="18451730">
            <a:off x="5608583" y="4749635"/>
            <a:ext cx="1212448" cy="36593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778" b="1" dirty="0">
                <a:latin typeface="Arial" panose="020B0604020202020204" pitchFamily="34" charset="0"/>
                <a:cs typeface="Arial" panose="020B0604020202020204" pitchFamily="34" charset="0"/>
              </a:rPr>
              <a:t>B16-OVA 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ED35EAF-8E82-49E1-AB44-5B590D46BEE7}"/>
              </a:ext>
            </a:extLst>
          </p:cNvPr>
          <p:cNvSpPr txBox="1"/>
          <p:nvPr/>
        </p:nvSpPr>
        <p:spPr>
          <a:xfrm>
            <a:off x="3760309" y="5512390"/>
            <a:ext cx="982961" cy="3659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78" b="1" dirty="0">
                <a:latin typeface="Arial" panose="020B0604020202020204" pitchFamily="34" charset="0"/>
                <a:cs typeface="Arial" panose="020B0604020202020204" pitchFamily="34" charset="0"/>
              </a:rPr>
              <a:t>gp100 -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C1BE7B92-4607-4746-B39A-FB1A2032B00D}"/>
              </a:ext>
            </a:extLst>
          </p:cNvPr>
          <p:cNvGrpSpPr/>
          <p:nvPr/>
        </p:nvGrpSpPr>
        <p:grpSpPr>
          <a:xfrm>
            <a:off x="4875919" y="5454559"/>
            <a:ext cx="1799419" cy="1840069"/>
            <a:chOff x="2742704" y="3068189"/>
            <a:chExt cx="1350244" cy="1544882"/>
          </a:xfrm>
        </p:grpSpPr>
        <p:graphicFrame>
          <p:nvGraphicFramePr>
            <p:cNvPr id="29" name="Object 28">
              <a:extLst>
                <a:ext uri="{FF2B5EF4-FFF2-40B4-BE49-F238E27FC236}">
                  <a16:creationId xmlns:a16="http://schemas.microsoft.com/office/drawing/2014/main" id="{095AD4EC-6361-496B-9F15-727733060259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2747019" y="4118153"/>
            <a:ext cx="1340387" cy="49491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8" name="Image" r:id="rId3" imgW="543240" imgH="217080" progId="Photoshop.Image.16">
                    <p:embed/>
                  </p:oleObj>
                </mc:Choice>
                <mc:Fallback>
                  <p:oleObj name="Image" r:id="rId3" imgW="543240" imgH="217080" progId="Photoshop.Image.16">
                    <p:embed/>
                    <p:pic>
                      <p:nvPicPr>
                        <p:cNvPr id="29" name="Object 28">
                          <a:extLst>
                            <a:ext uri="{FF2B5EF4-FFF2-40B4-BE49-F238E27FC236}">
                              <a16:creationId xmlns:a16="http://schemas.microsoft.com/office/drawing/2014/main" id="{095AD4EC-6361-496B-9F15-72773306025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747019" y="4118153"/>
                          <a:ext cx="1340387" cy="49491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0" name="Object 29">
              <a:extLst>
                <a:ext uri="{FF2B5EF4-FFF2-40B4-BE49-F238E27FC236}">
                  <a16:creationId xmlns:a16="http://schemas.microsoft.com/office/drawing/2014/main" id="{95FE54E1-4F0B-40A4-90A0-E4615C3616E6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2743572" y="3605645"/>
            <a:ext cx="1343834" cy="4747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9" name="Image" r:id="rId5" imgW="531000" imgH="203400" progId="Photoshop.Image.16">
                    <p:embed/>
                  </p:oleObj>
                </mc:Choice>
                <mc:Fallback>
                  <p:oleObj name="Image" r:id="rId5" imgW="531000" imgH="203400" progId="Photoshop.Image.16">
                    <p:embed/>
                    <p:pic>
                      <p:nvPicPr>
                        <p:cNvPr id="30" name="Object 29">
                          <a:extLst>
                            <a:ext uri="{FF2B5EF4-FFF2-40B4-BE49-F238E27FC236}">
                              <a16:creationId xmlns:a16="http://schemas.microsoft.com/office/drawing/2014/main" id="{95FE54E1-4F0B-40A4-90A0-E4615C3616E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743572" y="3605645"/>
                          <a:ext cx="1343834" cy="4747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2" name="Object 41">
              <a:extLst>
                <a:ext uri="{FF2B5EF4-FFF2-40B4-BE49-F238E27FC236}">
                  <a16:creationId xmlns:a16="http://schemas.microsoft.com/office/drawing/2014/main" id="{8F71693A-3848-47FB-84CC-4E9429E9622E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2742704" y="3068189"/>
            <a:ext cx="1350244" cy="49491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0" r:id="rId7" imgW="689400" imgH="210960" progId="">
                    <p:embed/>
                  </p:oleObj>
                </mc:Choice>
                <mc:Fallback>
                  <p:oleObj r:id="rId7" imgW="689400" imgH="210960" progId="">
                    <p:embed/>
                    <p:pic>
                      <p:nvPicPr>
                        <p:cNvPr id="42" name="Object 41">
                          <a:extLst>
                            <a:ext uri="{FF2B5EF4-FFF2-40B4-BE49-F238E27FC236}">
                              <a16:creationId xmlns:a16="http://schemas.microsoft.com/office/drawing/2014/main" id="{8F71693A-3848-47FB-84CC-4E9429E9622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2742704" y="3068189"/>
                          <a:ext cx="1350244" cy="49491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113950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44</Words>
  <Application>Microsoft Office PowerPoint</Application>
  <PresentationFormat>Custom</PresentationFormat>
  <Paragraphs>6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Imag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ng,Hong</dc:creator>
  <cp:lastModifiedBy>Jiang,Hong</cp:lastModifiedBy>
  <cp:revision>5</cp:revision>
  <dcterms:created xsi:type="dcterms:W3CDTF">2022-10-17T17:34:53Z</dcterms:created>
  <dcterms:modified xsi:type="dcterms:W3CDTF">2022-12-14T16:03:50Z</dcterms:modified>
</cp:coreProperties>
</file>